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1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192" y="2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3">
  <dgm:title val=""/>
  <dgm:desc val=""/>
  <dgm:catLst>
    <dgm:cat type="colorful" pri="103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3"/>
      <a:schemeClr val="accent4"/>
    </dgm:fillClrLst>
    <dgm:linClrLst>
      <a:schemeClr val="accent3"/>
      <a:schemeClr val="accent4"/>
    </dgm:linClrLst>
    <dgm:effectClrLst/>
    <dgm:txLinClrLst/>
    <dgm:txFillClrLst/>
    <dgm:txEffectClrLst/>
  </dgm:styleLbl>
  <dgm:styleLbl name="lnNode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3">
        <a:alpha val="50000"/>
      </a:schemeClr>
      <a:schemeClr val="accent4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3">
        <a:tint val="50000"/>
      </a:schemeClr>
      <a:schemeClr val="accent4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3">
        <a:tint val="50000"/>
      </a:schemeClr>
      <a:schemeClr val="accent4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3"/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3"/>
      <a:schemeClr val="accent4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3"/>
      <a:schemeClr val="accent4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3">
        <a:tint val="40000"/>
        <a:alpha val="90000"/>
      </a:schemeClr>
      <a:schemeClr val="accent4">
        <a:tint val="40000"/>
        <a:alpha val="90000"/>
      </a:schemeClr>
    </dgm:fillClrLst>
    <dgm:linClrLst>
      <a:schemeClr val="accent3">
        <a:tint val="40000"/>
        <a:alpha val="90000"/>
      </a:schemeClr>
      <a:schemeClr val="accent4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0D87686-1899-4E62-9295-E437A6237C9E}" type="doc">
      <dgm:prSet loTypeId="urn:microsoft.com/office/officeart/2005/8/layout/hProcess4" loCatId="process" qsTypeId="urn:microsoft.com/office/officeart/2005/8/quickstyle/simple1" qsCatId="simple" csTypeId="urn:microsoft.com/office/officeart/2005/8/colors/colorful3" csCatId="colorful" phldr="1"/>
      <dgm:spPr/>
      <dgm:t>
        <a:bodyPr/>
        <a:lstStyle/>
        <a:p>
          <a:endParaRPr lang="en-US"/>
        </a:p>
      </dgm:t>
    </dgm:pt>
    <dgm:pt modelId="{9641D7F7-C3D9-42E5-AD3B-8A4515792FC6}">
      <dgm:prSet>
        <dgm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r>
            <a:rPr lang="en-US" dirty="0"/>
            <a:t>Context</a:t>
          </a:r>
        </a:p>
      </dgm:t>
    </dgm:pt>
    <dgm:pt modelId="{2A0C8DA3-2B91-4D36-AC5A-76524B098347}" type="parTrans" cxnId="{303FDFE4-16C9-4EF0-AD4F-C2DC673AAF3E}">
      <dgm:prSet/>
      <dgm:spPr/>
      <dgm:t>
        <a:bodyPr/>
        <a:lstStyle/>
        <a:p>
          <a:endParaRPr lang="en-US"/>
        </a:p>
      </dgm:t>
    </dgm:pt>
    <dgm:pt modelId="{9CE39650-34FD-4C53-9FCB-6BAD6D74FCC3}" type="sibTrans" cxnId="{303FDFE4-16C9-4EF0-AD4F-C2DC673AAF3E}">
      <dgm:prSet/>
      <dgm:spPr/>
      <dgm:t>
        <a:bodyPr/>
        <a:lstStyle/>
        <a:p>
          <a:endParaRPr lang="en-US"/>
        </a:p>
      </dgm:t>
    </dgm:pt>
    <dgm:pt modelId="{8A2434C7-C556-4AE5-B6AD-70D19B31011A}">
      <dgm:prSet>
        <dgm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dgm:style>
      </dgm:prSet>
      <dgm:spPr>
        <a:gradFill rotWithShape="0">
          <a:gsLst>
            <a:gs pos="0">
              <a:schemeClr val="tx1">
                <a:lumMod val="65000"/>
                <a:lumOff val="35000"/>
              </a:schemeClr>
            </a:gs>
            <a:gs pos="50000">
              <a:schemeClr val="dk1">
                <a:satMod val="110000"/>
                <a:lumMod val="100000"/>
                <a:shade val="100000"/>
              </a:schemeClr>
            </a:gs>
            <a:gs pos="100000">
              <a:schemeClr val="dk1">
                <a:lumMod val="99000"/>
                <a:satMod val="120000"/>
                <a:shade val="78000"/>
              </a:schemeClr>
            </a:gs>
          </a:gsLst>
        </a:gradFill>
      </dgm:spPr>
      <dgm:t>
        <a:bodyPr/>
        <a:lstStyle/>
        <a:p>
          <a:r>
            <a:rPr lang="en-US" dirty="0"/>
            <a:t>Mechanism</a:t>
          </a:r>
        </a:p>
      </dgm:t>
    </dgm:pt>
    <dgm:pt modelId="{034EE9F8-E436-4320-B2E9-B868E6AB5713}" type="parTrans" cxnId="{8AE5CAD5-4BE6-4D0F-9939-4A83ADF06486}">
      <dgm:prSet/>
      <dgm:spPr/>
      <dgm:t>
        <a:bodyPr/>
        <a:lstStyle/>
        <a:p>
          <a:endParaRPr lang="en-US"/>
        </a:p>
      </dgm:t>
    </dgm:pt>
    <dgm:pt modelId="{9831D643-F932-44F7-8830-296F0D1FB9C5}" type="sibTrans" cxnId="{8AE5CAD5-4BE6-4D0F-9939-4A83ADF06486}">
      <dgm:prSet/>
      <dgm:spPr/>
      <dgm:t>
        <a:bodyPr/>
        <a:lstStyle/>
        <a:p>
          <a:endParaRPr lang="en-US"/>
        </a:p>
      </dgm:t>
    </dgm:pt>
    <dgm:pt modelId="{AF5DBA5C-AF6E-455C-B255-E4FAF734D552}">
      <dgm:prSet>
        <dgm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dgm:style>
      </dgm:prSet>
      <dgm:spPr>
        <a:gradFill rotWithShape="0">
          <a:gsLst>
            <a:gs pos="0">
              <a:schemeClr val="tx2"/>
            </a:gs>
            <a:gs pos="50000">
              <a:schemeClr val="dk1">
                <a:satMod val="110000"/>
                <a:lumMod val="100000"/>
                <a:shade val="100000"/>
              </a:schemeClr>
            </a:gs>
            <a:gs pos="100000">
              <a:schemeClr val="dk1">
                <a:lumMod val="99000"/>
                <a:satMod val="120000"/>
                <a:shade val="78000"/>
              </a:schemeClr>
            </a:gs>
          </a:gsLst>
        </a:gradFill>
      </dgm:spPr>
      <dgm:t>
        <a:bodyPr/>
        <a:lstStyle/>
        <a:p>
          <a:r>
            <a:rPr lang="en-US" dirty="0"/>
            <a:t>Outcome</a:t>
          </a:r>
        </a:p>
      </dgm:t>
    </dgm:pt>
    <dgm:pt modelId="{5303CA1D-0929-4331-85EF-40C678B41803}" type="parTrans" cxnId="{E17CADCE-5DDF-46B9-8C19-1CC7850DC13B}">
      <dgm:prSet/>
      <dgm:spPr/>
      <dgm:t>
        <a:bodyPr/>
        <a:lstStyle/>
        <a:p>
          <a:endParaRPr lang="en-US"/>
        </a:p>
      </dgm:t>
    </dgm:pt>
    <dgm:pt modelId="{7110B460-B38D-4864-A590-4D92AD2465F5}" type="sibTrans" cxnId="{E17CADCE-5DDF-46B9-8C19-1CC7850DC13B}">
      <dgm:prSet/>
      <dgm:spPr/>
      <dgm:t>
        <a:bodyPr/>
        <a:lstStyle/>
        <a:p>
          <a:endParaRPr lang="en-US"/>
        </a:p>
      </dgm:t>
    </dgm:pt>
    <dgm:pt modelId="{85C9B31C-EDDF-41EE-8BBF-2177029A8A24}">
      <dgm:prSet custT="1"/>
      <dgm:spPr/>
      <dgm:t>
        <a:bodyPr/>
        <a:lstStyle/>
        <a:p>
          <a:pPr>
            <a:buFont typeface="Arial" panose="020B0604020202020204" pitchFamily="34" charset="0"/>
            <a:buChar char="•"/>
          </a:pPr>
          <a:r>
            <a:rPr lang="en-US" sz="1500" b="0" dirty="0">
              <a:latin typeface="Times New Roman" panose="02020603050405020304" pitchFamily="18" charset="0"/>
              <a:cs typeface="Times New Roman" panose="02020603050405020304" pitchFamily="18" charset="0"/>
            </a:rPr>
            <a:t>Patient partners educational background did not include training about clinical trials. They are not experienced researchers</a:t>
          </a:r>
        </a:p>
      </dgm:t>
    </dgm:pt>
    <dgm:pt modelId="{A17FC32F-0C2F-42B9-8666-F918A78BB063}" type="parTrans" cxnId="{BECF012A-54A6-4E24-B8F2-5DCA0C9F396D}">
      <dgm:prSet/>
      <dgm:spPr/>
      <dgm:t>
        <a:bodyPr/>
        <a:lstStyle/>
        <a:p>
          <a:endParaRPr lang="en-US"/>
        </a:p>
      </dgm:t>
    </dgm:pt>
    <dgm:pt modelId="{1E427983-A510-4043-B8D2-B6A100A23B8C}" type="sibTrans" cxnId="{BECF012A-54A6-4E24-B8F2-5DCA0C9F396D}">
      <dgm:prSet/>
      <dgm:spPr/>
      <dgm:t>
        <a:bodyPr/>
        <a:lstStyle/>
        <a:p>
          <a:endParaRPr lang="en-US"/>
        </a:p>
      </dgm:t>
    </dgm:pt>
    <dgm:pt modelId="{5784BA57-8CAD-4EFF-ACD5-4280799065B4}">
      <dgm:prSet custT="1"/>
      <dgm:spPr/>
      <dgm:t>
        <a:bodyPr/>
        <a:lstStyle/>
        <a:p>
          <a:r>
            <a:rPr lang="en-US" sz="1500" b="0" dirty="0">
              <a:latin typeface="Times New Roman" panose="02020603050405020304" pitchFamily="18" charset="0"/>
              <a:cs typeface="Times New Roman" panose="02020603050405020304" pitchFamily="18" charset="0"/>
            </a:rPr>
            <a:t>Academic researcher perceives patient partners’ readiness to research (in this case, their lack of readiness)</a:t>
          </a:r>
        </a:p>
      </dgm:t>
    </dgm:pt>
    <dgm:pt modelId="{2D349A81-C25D-477E-A093-E326C6F4DDB6}" type="parTrans" cxnId="{47645B2F-41FD-43EC-BBED-0D1C01D9D19B}">
      <dgm:prSet/>
      <dgm:spPr/>
      <dgm:t>
        <a:bodyPr/>
        <a:lstStyle/>
        <a:p>
          <a:endParaRPr lang="en-US"/>
        </a:p>
      </dgm:t>
    </dgm:pt>
    <dgm:pt modelId="{8A72E94C-97E3-4580-9EE2-D009C8216B3E}" type="sibTrans" cxnId="{47645B2F-41FD-43EC-BBED-0D1C01D9D19B}">
      <dgm:prSet/>
      <dgm:spPr/>
      <dgm:t>
        <a:bodyPr/>
        <a:lstStyle/>
        <a:p>
          <a:endParaRPr lang="en-US"/>
        </a:p>
      </dgm:t>
    </dgm:pt>
    <dgm:pt modelId="{3BCE602B-206F-49E6-880C-2C3504551ED2}">
      <dgm:prSet custT="1"/>
      <dgm:spPr/>
      <dgm:t>
        <a:bodyPr/>
        <a:lstStyle/>
        <a:p>
          <a:r>
            <a:rPr lang="en-US" sz="1500" b="0" dirty="0">
              <a:latin typeface="Times New Roman" panose="02020603050405020304" pitchFamily="18" charset="0"/>
              <a:cs typeface="Times New Roman" panose="02020603050405020304" pitchFamily="18" charset="0"/>
            </a:rPr>
            <a:t>Academic researcher perceives a sense of frustration over their need to educate patient partners</a:t>
          </a:r>
        </a:p>
      </dgm:t>
    </dgm:pt>
    <dgm:pt modelId="{12519D85-DB88-4C50-AA79-729DA7564EA1}" type="parTrans" cxnId="{3BCD5AEB-A2B1-407A-8685-31A41BFDD8AC}">
      <dgm:prSet/>
      <dgm:spPr/>
      <dgm:t>
        <a:bodyPr/>
        <a:lstStyle/>
        <a:p>
          <a:endParaRPr lang="en-US"/>
        </a:p>
      </dgm:t>
    </dgm:pt>
    <dgm:pt modelId="{F6581E3D-3C69-49CF-B4D0-C0193F5672B0}" type="sibTrans" cxnId="{3BCD5AEB-A2B1-407A-8685-31A41BFDD8AC}">
      <dgm:prSet/>
      <dgm:spPr/>
      <dgm:t>
        <a:bodyPr/>
        <a:lstStyle/>
        <a:p>
          <a:endParaRPr lang="en-US"/>
        </a:p>
      </dgm:t>
    </dgm:pt>
    <dgm:pt modelId="{7F77F868-C54B-9E45-A6B4-1B6C3D844298}">
      <dgm:prSet/>
      <dgm:spPr/>
      <dgm:t>
        <a:bodyPr/>
        <a:lstStyle/>
        <a:p>
          <a:pPr>
            <a:buFont typeface="Arial" panose="020B0604020202020204" pitchFamily="34" charset="0"/>
            <a:buNone/>
          </a:pPr>
          <a:endParaRPr lang="en-US" sz="1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25EE558-4FB1-E34E-8707-D0FEE095A64B}" type="parTrans" cxnId="{E0F54FF0-5936-E745-A128-43875F934DB5}">
      <dgm:prSet/>
      <dgm:spPr/>
      <dgm:t>
        <a:bodyPr/>
        <a:lstStyle/>
        <a:p>
          <a:endParaRPr lang="en-US"/>
        </a:p>
      </dgm:t>
    </dgm:pt>
    <dgm:pt modelId="{8F2071F1-1FA7-9F46-975E-A459658CDA05}" type="sibTrans" cxnId="{E0F54FF0-5936-E745-A128-43875F934DB5}">
      <dgm:prSet/>
      <dgm:spPr/>
      <dgm:t>
        <a:bodyPr/>
        <a:lstStyle/>
        <a:p>
          <a:endParaRPr lang="en-US"/>
        </a:p>
      </dgm:t>
    </dgm:pt>
    <dgm:pt modelId="{5CD45315-30D7-CE41-9C04-4B7D66409AFB}">
      <dgm:prSet/>
      <dgm:spPr/>
      <dgm:t>
        <a:bodyPr/>
        <a:lstStyle/>
        <a:p>
          <a:pPr>
            <a:buFont typeface="Arial" panose="020B0604020202020204" pitchFamily="34" charset="0"/>
            <a:buNone/>
          </a:pPr>
          <a:endParaRPr lang="en-US" sz="1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0188B53-1697-ED43-845E-421AB6260FD9}" type="parTrans" cxnId="{F6EA6F2A-58E9-DA40-BC5F-759B6F1196BD}">
      <dgm:prSet/>
      <dgm:spPr/>
      <dgm:t>
        <a:bodyPr/>
        <a:lstStyle/>
        <a:p>
          <a:endParaRPr lang="en-US"/>
        </a:p>
      </dgm:t>
    </dgm:pt>
    <dgm:pt modelId="{95ADECB0-3EF2-4142-9E3D-3752CF272CE4}" type="sibTrans" cxnId="{F6EA6F2A-58E9-DA40-BC5F-759B6F1196BD}">
      <dgm:prSet/>
      <dgm:spPr/>
      <dgm:t>
        <a:bodyPr/>
        <a:lstStyle/>
        <a:p>
          <a:endParaRPr lang="en-US"/>
        </a:p>
      </dgm:t>
    </dgm:pt>
    <dgm:pt modelId="{1E069B16-796B-40C4-AD3F-19F1E3DE8F5F}" type="pres">
      <dgm:prSet presAssocID="{60D87686-1899-4E62-9295-E437A6237C9E}" presName="Name0" presStyleCnt="0">
        <dgm:presLayoutVars>
          <dgm:dir/>
          <dgm:animLvl val="lvl"/>
          <dgm:resizeHandles val="exact"/>
        </dgm:presLayoutVars>
      </dgm:prSet>
      <dgm:spPr/>
    </dgm:pt>
    <dgm:pt modelId="{2C834841-B0F0-45DC-BBE6-F6D810BFA62D}" type="pres">
      <dgm:prSet presAssocID="{60D87686-1899-4E62-9295-E437A6237C9E}" presName="tSp" presStyleCnt="0"/>
      <dgm:spPr/>
    </dgm:pt>
    <dgm:pt modelId="{8E4C6633-5F43-48FB-9174-432558B06AD6}" type="pres">
      <dgm:prSet presAssocID="{60D87686-1899-4E62-9295-E437A6237C9E}" presName="bSp" presStyleCnt="0"/>
      <dgm:spPr/>
    </dgm:pt>
    <dgm:pt modelId="{5B334655-8CE9-44EF-9EC6-34A1F349B77B}" type="pres">
      <dgm:prSet presAssocID="{60D87686-1899-4E62-9295-E437A6237C9E}" presName="process" presStyleCnt="0"/>
      <dgm:spPr/>
    </dgm:pt>
    <dgm:pt modelId="{BC25CBBA-EAC8-4A71-A20F-3E5E005C2C90}" type="pres">
      <dgm:prSet presAssocID="{9641D7F7-C3D9-42E5-AD3B-8A4515792FC6}" presName="composite1" presStyleCnt="0"/>
      <dgm:spPr/>
    </dgm:pt>
    <dgm:pt modelId="{8127892F-D27F-4E77-831C-F7D4A114C128}" type="pres">
      <dgm:prSet presAssocID="{9641D7F7-C3D9-42E5-AD3B-8A4515792FC6}" presName="dummyNode1" presStyleLbl="node1" presStyleIdx="0" presStyleCnt="3"/>
      <dgm:spPr/>
    </dgm:pt>
    <dgm:pt modelId="{C208CBE4-2ADB-4F7C-9557-AC3A47690629}" type="pres">
      <dgm:prSet presAssocID="{9641D7F7-C3D9-42E5-AD3B-8A4515792FC6}" presName="childNode1" presStyleLbl="bgAcc1" presStyleIdx="0" presStyleCnt="3" custLinFactNeighborX="1070" custLinFactNeighborY="-7783">
        <dgm:presLayoutVars>
          <dgm:bulletEnabled val="1"/>
        </dgm:presLayoutVars>
      </dgm:prSet>
      <dgm:spPr/>
    </dgm:pt>
    <dgm:pt modelId="{4F12158A-6FD3-45C0-90BF-A57B03859685}" type="pres">
      <dgm:prSet presAssocID="{9641D7F7-C3D9-42E5-AD3B-8A4515792FC6}" presName="childNode1tx" presStyleLbl="bgAcc1" presStyleIdx="0" presStyleCnt="3">
        <dgm:presLayoutVars>
          <dgm:bulletEnabled val="1"/>
        </dgm:presLayoutVars>
      </dgm:prSet>
      <dgm:spPr/>
    </dgm:pt>
    <dgm:pt modelId="{7A3B0638-4798-4C67-99BB-21C7FC8B54AD}" type="pres">
      <dgm:prSet presAssocID="{9641D7F7-C3D9-42E5-AD3B-8A4515792FC6}" presName="parentNode1" presStyleLbl="node1" presStyleIdx="0" presStyleCnt="3">
        <dgm:presLayoutVars>
          <dgm:chMax val="1"/>
          <dgm:bulletEnabled val="1"/>
        </dgm:presLayoutVars>
      </dgm:prSet>
      <dgm:spPr/>
    </dgm:pt>
    <dgm:pt modelId="{35C32C4D-BCDF-4BFD-BECF-71C479DCBE8B}" type="pres">
      <dgm:prSet presAssocID="{9641D7F7-C3D9-42E5-AD3B-8A4515792FC6}" presName="connSite1" presStyleCnt="0"/>
      <dgm:spPr/>
    </dgm:pt>
    <dgm:pt modelId="{4FF0DDFF-DF08-466A-99C3-B255489F7E98}" type="pres">
      <dgm:prSet presAssocID="{9CE39650-34FD-4C53-9FCB-6BAD6D74FCC3}" presName="Name9" presStyleLbl="sibTrans2D1" presStyleIdx="0" presStyleCnt="2"/>
      <dgm:spPr/>
    </dgm:pt>
    <dgm:pt modelId="{D94C43D7-1E5E-4F75-AEEC-C369DC99AE4A}" type="pres">
      <dgm:prSet presAssocID="{8A2434C7-C556-4AE5-B6AD-70D19B31011A}" presName="composite2" presStyleCnt="0"/>
      <dgm:spPr/>
    </dgm:pt>
    <dgm:pt modelId="{C022D71F-067D-468F-94D7-6FD068FF4B60}" type="pres">
      <dgm:prSet presAssocID="{8A2434C7-C556-4AE5-B6AD-70D19B31011A}" presName="dummyNode2" presStyleLbl="node1" presStyleIdx="0" presStyleCnt="3"/>
      <dgm:spPr/>
    </dgm:pt>
    <dgm:pt modelId="{5412F56F-93F3-4242-95C3-38727FCF1745}" type="pres">
      <dgm:prSet presAssocID="{8A2434C7-C556-4AE5-B6AD-70D19B31011A}" presName="childNode2" presStyleLbl="bgAcc1" presStyleIdx="1" presStyleCnt="3">
        <dgm:presLayoutVars>
          <dgm:bulletEnabled val="1"/>
        </dgm:presLayoutVars>
      </dgm:prSet>
      <dgm:spPr/>
    </dgm:pt>
    <dgm:pt modelId="{00474DAD-2020-4148-94B6-83A646F066D7}" type="pres">
      <dgm:prSet presAssocID="{8A2434C7-C556-4AE5-B6AD-70D19B31011A}" presName="childNode2tx" presStyleLbl="bgAcc1" presStyleIdx="1" presStyleCnt="3">
        <dgm:presLayoutVars>
          <dgm:bulletEnabled val="1"/>
        </dgm:presLayoutVars>
      </dgm:prSet>
      <dgm:spPr/>
    </dgm:pt>
    <dgm:pt modelId="{02C7E8F2-C81A-4039-8494-624928C37673}" type="pres">
      <dgm:prSet presAssocID="{8A2434C7-C556-4AE5-B6AD-70D19B31011A}" presName="parentNode2" presStyleLbl="node1" presStyleIdx="1" presStyleCnt="3">
        <dgm:presLayoutVars>
          <dgm:chMax val="0"/>
          <dgm:bulletEnabled val="1"/>
        </dgm:presLayoutVars>
      </dgm:prSet>
      <dgm:spPr/>
    </dgm:pt>
    <dgm:pt modelId="{25B2990B-BAD3-4F16-8E36-F73CB9E6624F}" type="pres">
      <dgm:prSet presAssocID="{8A2434C7-C556-4AE5-B6AD-70D19B31011A}" presName="connSite2" presStyleCnt="0"/>
      <dgm:spPr/>
    </dgm:pt>
    <dgm:pt modelId="{6672AEE6-8509-4FED-9F07-0B28892F3E01}" type="pres">
      <dgm:prSet presAssocID="{9831D643-F932-44F7-8830-296F0D1FB9C5}" presName="Name18" presStyleLbl="sibTrans2D1" presStyleIdx="1" presStyleCnt="2"/>
      <dgm:spPr/>
    </dgm:pt>
    <dgm:pt modelId="{F3F68AC9-0F9C-4FA6-A7B2-AF1E66043D18}" type="pres">
      <dgm:prSet presAssocID="{AF5DBA5C-AF6E-455C-B255-E4FAF734D552}" presName="composite1" presStyleCnt="0"/>
      <dgm:spPr/>
    </dgm:pt>
    <dgm:pt modelId="{0977BC9C-FE03-487E-A7EC-A9058E237AF3}" type="pres">
      <dgm:prSet presAssocID="{AF5DBA5C-AF6E-455C-B255-E4FAF734D552}" presName="dummyNode1" presStyleLbl="node1" presStyleIdx="1" presStyleCnt="3"/>
      <dgm:spPr/>
    </dgm:pt>
    <dgm:pt modelId="{B118BAD4-2ED1-4EB5-AE0C-2C119827D1D4}" type="pres">
      <dgm:prSet presAssocID="{AF5DBA5C-AF6E-455C-B255-E4FAF734D552}" presName="childNode1" presStyleLbl="bgAcc1" presStyleIdx="2" presStyleCnt="3" custLinFactNeighborX="1899" custLinFactNeighborY="7074">
        <dgm:presLayoutVars>
          <dgm:bulletEnabled val="1"/>
        </dgm:presLayoutVars>
      </dgm:prSet>
      <dgm:spPr/>
    </dgm:pt>
    <dgm:pt modelId="{A89FDBBF-15DC-4CD4-945F-A94263069597}" type="pres">
      <dgm:prSet presAssocID="{AF5DBA5C-AF6E-455C-B255-E4FAF734D552}" presName="childNode1tx" presStyleLbl="bgAcc1" presStyleIdx="2" presStyleCnt="3">
        <dgm:presLayoutVars>
          <dgm:bulletEnabled val="1"/>
        </dgm:presLayoutVars>
      </dgm:prSet>
      <dgm:spPr/>
    </dgm:pt>
    <dgm:pt modelId="{A543B595-5D4C-4FF3-AD91-0DC27AAAA981}" type="pres">
      <dgm:prSet presAssocID="{AF5DBA5C-AF6E-455C-B255-E4FAF734D552}" presName="parentNode1" presStyleLbl="node1" presStyleIdx="2" presStyleCnt="3" custScaleX="100010" custScaleY="91606">
        <dgm:presLayoutVars>
          <dgm:chMax val="1"/>
          <dgm:bulletEnabled val="1"/>
        </dgm:presLayoutVars>
      </dgm:prSet>
      <dgm:spPr/>
    </dgm:pt>
    <dgm:pt modelId="{F088B1F5-2013-49F0-AC32-01CE1340DBAC}" type="pres">
      <dgm:prSet presAssocID="{AF5DBA5C-AF6E-455C-B255-E4FAF734D552}" presName="connSite1" presStyleCnt="0"/>
      <dgm:spPr/>
    </dgm:pt>
  </dgm:ptLst>
  <dgm:cxnLst>
    <dgm:cxn modelId="{8A4E2501-D1F3-6043-BBD3-C4684D92A684}" type="presOf" srcId="{5CD45315-30D7-CE41-9C04-4B7D66409AFB}" destId="{C208CBE4-2ADB-4F7C-9557-AC3A47690629}" srcOrd="0" destOrd="0" presId="urn:microsoft.com/office/officeart/2005/8/layout/hProcess4"/>
    <dgm:cxn modelId="{7FAC5306-A0A5-9449-AEAE-5415ED2E87F1}" type="presOf" srcId="{7F77F868-C54B-9E45-A6B4-1B6C3D844298}" destId="{4F12158A-6FD3-45C0-90BF-A57B03859685}" srcOrd="1" destOrd="2" presId="urn:microsoft.com/office/officeart/2005/8/layout/hProcess4"/>
    <dgm:cxn modelId="{A2C0AD0E-A7DC-4A31-9365-E603F3D17BB1}" type="presOf" srcId="{5784BA57-8CAD-4EFF-ACD5-4280799065B4}" destId="{5412F56F-93F3-4242-95C3-38727FCF1745}" srcOrd="0" destOrd="0" presId="urn:microsoft.com/office/officeart/2005/8/layout/hProcess4"/>
    <dgm:cxn modelId="{8F5D2C15-46B0-4C37-B518-4B413DDA2A2E}" type="presOf" srcId="{85C9B31C-EDDF-41EE-8BBF-2177029A8A24}" destId="{4F12158A-6FD3-45C0-90BF-A57B03859685}" srcOrd="1" destOrd="1" presId="urn:microsoft.com/office/officeart/2005/8/layout/hProcess4"/>
    <dgm:cxn modelId="{BECF012A-54A6-4E24-B8F2-5DCA0C9F396D}" srcId="{9641D7F7-C3D9-42E5-AD3B-8A4515792FC6}" destId="{85C9B31C-EDDF-41EE-8BBF-2177029A8A24}" srcOrd="1" destOrd="0" parTransId="{A17FC32F-0C2F-42B9-8666-F918A78BB063}" sibTransId="{1E427983-A510-4043-B8D2-B6A100A23B8C}"/>
    <dgm:cxn modelId="{F6EA6F2A-58E9-DA40-BC5F-759B6F1196BD}" srcId="{9641D7F7-C3D9-42E5-AD3B-8A4515792FC6}" destId="{5CD45315-30D7-CE41-9C04-4B7D66409AFB}" srcOrd="0" destOrd="0" parTransId="{90188B53-1697-ED43-845E-421AB6260FD9}" sibTransId="{95ADECB0-3EF2-4142-9E3D-3752CF272CE4}"/>
    <dgm:cxn modelId="{47645B2F-41FD-43EC-BBED-0D1C01D9D19B}" srcId="{8A2434C7-C556-4AE5-B6AD-70D19B31011A}" destId="{5784BA57-8CAD-4EFF-ACD5-4280799065B4}" srcOrd="0" destOrd="0" parTransId="{2D349A81-C25D-477E-A093-E326C6F4DDB6}" sibTransId="{8A72E94C-97E3-4580-9EE2-D009C8216B3E}"/>
    <dgm:cxn modelId="{E596BA40-9CAD-4431-8F46-0B4856572317}" type="presOf" srcId="{9831D643-F932-44F7-8830-296F0D1FB9C5}" destId="{6672AEE6-8509-4FED-9F07-0B28892F3E01}" srcOrd="0" destOrd="0" presId="urn:microsoft.com/office/officeart/2005/8/layout/hProcess4"/>
    <dgm:cxn modelId="{89415845-E82A-4BF8-A8B3-C4C2284BCBB8}" type="presOf" srcId="{8A2434C7-C556-4AE5-B6AD-70D19B31011A}" destId="{02C7E8F2-C81A-4039-8494-624928C37673}" srcOrd="0" destOrd="0" presId="urn:microsoft.com/office/officeart/2005/8/layout/hProcess4"/>
    <dgm:cxn modelId="{56D58747-7B5B-4ED5-8A99-AB794DEBA52D}" type="presOf" srcId="{85C9B31C-EDDF-41EE-8BBF-2177029A8A24}" destId="{C208CBE4-2ADB-4F7C-9557-AC3A47690629}" srcOrd="0" destOrd="1" presId="urn:microsoft.com/office/officeart/2005/8/layout/hProcess4"/>
    <dgm:cxn modelId="{0BDBAA68-6F4E-44E5-9887-C46A475AFD81}" type="presOf" srcId="{9641D7F7-C3D9-42E5-AD3B-8A4515792FC6}" destId="{7A3B0638-4798-4C67-99BB-21C7FC8B54AD}" srcOrd="0" destOrd="0" presId="urn:microsoft.com/office/officeart/2005/8/layout/hProcess4"/>
    <dgm:cxn modelId="{8A12728F-D349-1E4D-B646-99C6CF4CEEB4}" type="presOf" srcId="{7F77F868-C54B-9E45-A6B4-1B6C3D844298}" destId="{C208CBE4-2ADB-4F7C-9557-AC3A47690629}" srcOrd="0" destOrd="2" presId="urn:microsoft.com/office/officeart/2005/8/layout/hProcess4"/>
    <dgm:cxn modelId="{0EDF7D98-530A-D04D-8E3D-328DE7AE1243}" type="presOf" srcId="{5CD45315-30D7-CE41-9C04-4B7D66409AFB}" destId="{4F12158A-6FD3-45C0-90BF-A57B03859685}" srcOrd="1" destOrd="0" presId="urn:microsoft.com/office/officeart/2005/8/layout/hProcess4"/>
    <dgm:cxn modelId="{09EE2EB0-B586-41B9-9BF8-E5E87E19404F}" type="presOf" srcId="{60D87686-1899-4E62-9295-E437A6237C9E}" destId="{1E069B16-796B-40C4-AD3F-19F1E3DE8F5F}" srcOrd="0" destOrd="0" presId="urn:microsoft.com/office/officeart/2005/8/layout/hProcess4"/>
    <dgm:cxn modelId="{E17CADCE-5DDF-46B9-8C19-1CC7850DC13B}" srcId="{60D87686-1899-4E62-9295-E437A6237C9E}" destId="{AF5DBA5C-AF6E-455C-B255-E4FAF734D552}" srcOrd="2" destOrd="0" parTransId="{5303CA1D-0929-4331-85EF-40C678B41803}" sibTransId="{7110B460-B38D-4864-A590-4D92AD2465F5}"/>
    <dgm:cxn modelId="{20D0F9CE-303C-4FF8-BA13-017A3CCF0AA5}" type="presOf" srcId="{9CE39650-34FD-4C53-9FCB-6BAD6D74FCC3}" destId="{4FF0DDFF-DF08-466A-99C3-B255489F7E98}" srcOrd="0" destOrd="0" presId="urn:microsoft.com/office/officeart/2005/8/layout/hProcess4"/>
    <dgm:cxn modelId="{8AE5CAD5-4BE6-4D0F-9939-4A83ADF06486}" srcId="{60D87686-1899-4E62-9295-E437A6237C9E}" destId="{8A2434C7-C556-4AE5-B6AD-70D19B31011A}" srcOrd="1" destOrd="0" parTransId="{034EE9F8-E436-4320-B2E9-B868E6AB5713}" sibTransId="{9831D643-F932-44F7-8830-296F0D1FB9C5}"/>
    <dgm:cxn modelId="{303FDFE4-16C9-4EF0-AD4F-C2DC673AAF3E}" srcId="{60D87686-1899-4E62-9295-E437A6237C9E}" destId="{9641D7F7-C3D9-42E5-AD3B-8A4515792FC6}" srcOrd="0" destOrd="0" parTransId="{2A0C8DA3-2B91-4D36-AC5A-76524B098347}" sibTransId="{9CE39650-34FD-4C53-9FCB-6BAD6D74FCC3}"/>
    <dgm:cxn modelId="{B5578FE7-3A74-40D1-AB87-E9F8D255BF7C}" type="presOf" srcId="{3BCE602B-206F-49E6-880C-2C3504551ED2}" destId="{A89FDBBF-15DC-4CD4-945F-A94263069597}" srcOrd="1" destOrd="0" presId="urn:microsoft.com/office/officeart/2005/8/layout/hProcess4"/>
    <dgm:cxn modelId="{7389ECE7-DA9B-44AF-AF57-656C75BAF64F}" type="presOf" srcId="{5784BA57-8CAD-4EFF-ACD5-4280799065B4}" destId="{00474DAD-2020-4148-94B6-83A646F066D7}" srcOrd="1" destOrd="0" presId="urn:microsoft.com/office/officeart/2005/8/layout/hProcess4"/>
    <dgm:cxn modelId="{3BCD5AEB-A2B1-407A-8685-31A41BFDD8AC}" srcId="{AF5DBA5C-AF6E-455C-B255-E4FAF734D552}" destId="{3BCE602B-206F-49E6-880C-2C3504551ED2}" srcOrd="0" destOrd="0" parTransId="{12519D85-DB88-4C50-AA79-729DA7564EA1}" sibTransId="{F6581E3D-3C69-49CF-B4D0-C0193F5672B0}"/>
    <dgm:cxn modelId="{E0F54FF0-5936-E745-A128-43875F934DB5}" srcId="{9641D7F7-C3D9-42E5-AD3B-8A4515792FC6}" destId="{7F77F868-C54B-9E45-A6B4-1B6C3D844298}" srcOrd="2" destOrd="0" parTransId="{F25EE558-4FB1-E34E-8707-D0FEE095A64B}" sibTransId="{8F2071F1-1FA7-9F46-975E-A459658CDA05}"/>
    <dgm:cxn modelId="{59B575F4-8AA1-4097-8B44-5D4DDDDF55B5}" type="presOf" srcId="{3BCE602B-206F-49E6-880C-2C3504551ED2}" destId="{B118BAD4-2ED1-4EB5-AE0C-2C119827D1D4}" srcOrd="0" destOrd="0" presId="urn:microsoft.com/office/officeart/2005/8/layout/hProcess4"/>
    <dgm:cxn modelId="{020A16FC-AFEA-4258-9C68-99AE586DA924}" type="presOf" srcId="{AF5DBA5C-AF6E-455C-B255-E4FAF734D552}" destId="{A543B595-5D4C-4FF3-AD91-0DC27AAAA981}" srcOrd="0" destOrd="0" presId="urn:microsoft.com/office/officeart/2005/8/layout/hProcess4"/>
    <dgm:cxn modelId="{FBC4A82C-9C3B-4E68-A379-B49052E88CCE}" type="presParOf" srcId="{1E069B16-796B-40C4-AD3F-19F1E3DE8F5F}" destId="{2C834841-B0F0-45DC-BBE6-F6D810BFA62D}" srcOrd="0" destOrd="0" presId="urn:microsoft.com/office/officeart/2005/8/layout/hProcess4"/>
    <dgm:cxn modelId="{173F7A96-DA64-4C68-82B7-873E41C5886F}" type="presParOf" srcId="{1E069B16-796B-40C4-AD3F-19F1E3DE8F5F}" destId="{8E4C6633-5F43-48FB-9174-432558B06AD6}" srcOrd="1" destOrd="0" presId="urn:microsoft.com/office/officeart/2005/8/layout/hProcess4"/>
    <dgm:cxn modelId="{A68A3084-863F-460B-9945-8084181D02A2}" type="presParOf" srcId="{1E069B16-796B-40C4-AD3F-19F1E3DE8F5F}" destId="{5B334655-8CE9-44EF-9EC6-34A1F349B77B}" srcOrd="2" destOrd="0" presId="urn:microsoft.com/office/officeart/2005/8/layout/hProcess4"/>
    <dgm:cxn modelId="{B4059C9E-82C5-48B4-B52A-63AA43565208}" type="presParOf" srcId="{5B334655-8CE9-44EF-9EC6-34A1F349B77B}" destId="{BC25CBBA-EAC8-4A71-A20F-3E5E005C2C90}" srcOrd="0" destOrd="0" presId="urn:microsoft.com/office/officeart/2005/8/layout/hProcess4"/>
    <dgm:cxn modelId="{8548DEEA-35CA-4399-B62E-F373E2584892}" type="presParOf" srcId="{BC25CBBA-EAC8-4A71-A20F-3E5E005C2C90}" destId="{8127892F-D27F-4E77-831C-F7D4A114C128}" srcOrd="0" destOrd="0" presId="urn:microsoft.com/office/officeart/2005/8/layout/hProcess4"/>
    <dgm:cxn modelId="{7CB889F0-E4B5-4D7B-B4F5-818C549872CE}" type="presParOf" srcId="{BC25CBBA-EAC8-4A71-A20F-3E5E005C2C90}" destId="{C208CBE4-2ADB-4F7C-9557-AC3A47690629}" srcOrd="1" destOrd="0" presId="urn:microsoft.com/office/officeart/2005/8/layout/hProcess4"/>
    <dgm:cxn modelId="{2D65776B-8909-41FA-8AA7-775E3F3A4C43}" type="presParOf" srcId="{BC25CBBA-EAC8-4A71-A20F-3E5E005C2C90}" destId="{4F12158A-6FD3-45C0-90BF-A57B03859685}" srcOrd="2" destOrd="0" presId="urn:microsoft.com/office/officeart/2005/8/layout/hProcess4"/>
    <dgm:cxn modelId="{6BB0686A-C573-47FC-93B0-829473E9B716}" type="presParOf" srcId="{BC25CBBA-EAC8-4A71-A20F-3E5E005C2C90}" destId="{7A3B0638-4798-4C67-99BB-21C7FC8B54AD}" srcOrd="3" destOrd="0" presId="urn:microsoft.com/office/officeart/2005/8/layout/hProcess4"/>
    <dgm:cxn modelId="{8FB148F4-77A3-42D2-BEA2-3908E6A910AA}" type="presParOf" srcId="{BC25CBBA-EAC8-4A71-A20F-3E5E005C2C90}" destId="{35C32C4D-BCDF-4BFD-BECF-71C479DCBE8B}" srcOrd="4" destOrd="0" presId="urn:microsoft.com/office/officeart/2005/8/layout/hProcess4"/>
    <dgm:cxn modelId="{81CE716A-D991-4E97-9334-76DB3504B868}" type="presParOf" srcId="{5B334655-8CE9-44EF-9EC6-34A1F349B77B}" destId="{4FF0DDFF-DF08-466A-99C3-B255489F7E98}" srcOrd="1" destOrd="0" presId="urn:microsoft.com/office/officeart/2005/8/layout/hProcess4"/>
    <dgm:cxn modelId="{65D61A81-3F0C-4B27-9A76-3424950709D4}" type="presParOf" srcId="{5B334655-8CE9-44EF-9EC6-34A1F349B77B}" destId="{D94C43D7-1E5E-4F75-AEEC-C369DC99AE4A}" srcOrd="2" destOrd="0" presId="urn:microsoft.com/office/officeart/2005/8/layout/hProcess4"/>
    <dgm:cxn modelId="{49968AA6-FAC8-4360-A925-923A09FC4A46}" type="presParOf" srcId="{D94C43D7-1E5E-4F75-AEEC-C369DC99AE4A}" destId="{C022D71F-067D-468F-94D7-6FD068FF4B60}" srcOrd="0" destOrd="0" presId="urn:microsoft.com/office/officeart/2005/8/layout/hProcess4"/>
    <dgm:cxn modelId="{F47EE26C-5E8C-4157-AFCB-9E27E6027910}" type="presParOf" srcId="{D94C43D7-1E5E-4F75-AEEC-C369DC99AE4A}" destId="{5412F56F-93F3-4242-95C3-38727FCF1745}" srcOrd="1" destOrd="0" presId="urn:microsoft.com/office/officeart/2005/8/layout/hProcess4"/>
    <dgm:cxn modelId="{A653BAFB-947C-4F15-84B7-B2E0472A04FA}" type="presParOf" srcId="{D94C43D7-1E5E-4F75-AEEC-C369DC99AE4A}" destId="{00474DAD-2020-4148-94B6-83A646F066D7}" srcOrd="2" destOrd="0" presId="urn:microsoft.com/office/officeart/2005/8/layout/hProcess4"/>
    <dgm:cxn modelId="{CF9AD9E7-9420-4CD4-8798-3D6E707CEFAD}" type="presParOf" srcId="{D94C43D7-1E5E-4F75-AEEC-C369DC99AE4A}" destId="{02C7E8F2-C81A-4039-8494-624928C37673}" srcOrd="3" destOrd="0" presId="urn:microsoft.com/office/officeart/2005/8/layout/hProcess4"/>
    <dgm:cxn modelId="{120B6127-B58A-4631-9A21-1C6AA4834AF0}" type="presParOf" srcId="{D94C43D7-1E5E-4F75-AEEC-C369DC99AE4A}" destId="{25B2990B-BAD3-4F16-8E36-F73CB9E6624F}" srcOrd="4" destOrd="0" presId="urn:microsoft.com/office/officeart/2005/8/layout/hProcess4"/>
    <dgm:cxn modelId="{3616E761-F27C-485D-9DCA-A406CAFEF2A1}" type="presParOf" srcId="{5B334655-8CE9-44EF-9EC6-34A1F349B77B}" destId="{6672AEE6-8509-4FED-9F07-0B28892F3E01}" srcOrd="3" destOrd="0" presId="urn:microsoft.com/office/officeart/2005/8/layout/hProcess4"/>
    <dgm:cxn modelId="{1C368D11-F555-4902-8D98-F49D731F4483}" type="presParOf" srcId="{5B334655-8CE9-44EF-9EC6-34A1F349B77B}" destId="{F3F68AC9-0F9C-4FA6-A7B2-AF1E66043D18}" srcOrd="4" destOrd="0" presId="urn:microsoft.com/office/officeart/2005/8/layout/hProcess4"/>
    <dgm:cxn modelId="{1B5D483B-BAEC-45EF-AE61-D65877F0D35D}" type="presParOf" srcId="{F3F68AC9-0F9C-4FA6-A7B2-AF1E66043D18}" destId="{0977BC9C-FE03-487E-A7EC-A9058E237AF3}" srcOrd="0" destOrd="0" presId="urn:microsoft.com/office/officeart/2005/8/layout/hProcess4"/>
    <dgm:cxn modelId="{94ACFE85-4E6B-440B-94A5-BB5E955B24F5}" type="presParOf" srcId="{F3F68AC9-0F9C-4FA6-A7B2-AF1E66043D18}" destId="{B118BAD4-2ED1-4EB5-AE0C-2C119827D1D4}" srcOrd="1" destOrd="0" presId="urn:microsoft.com/office/officeart/2005/8/layout/hProcess4"/>
    <dgm:cxn modelId="{4EDC0E63-FA8E-40AE-B548-A1D8EA126A74}" type="presParOf" srcId="{F3F68AC9-0F9C-4FA6-A7B2-AF1E66043D18}" destId="{A89FDBBF-15DC-4CD4-945F-A94263069597}" srcOrd="2" destOrd="0" presId="urn:microsoft.com/office/officeart/2005/8/layout/hProcess4"/>
    <dgm:cxn modelId="{8E2D3C84-CE47-4042-A7C6-63292FCF46AC}" type="presParOf" srcId="{F3F68AC9-0F9C-4FA6-A7B2-AF1E66043D18}" destId="{A543B595-5D4C-4FF3-AD91-0DC27AAAA981}" srcOrd="3" destOrd="0" presId="urn:microsoft.com/office/officeart/2005/8/layout/hProcess4"/>
    <dgm:cxn modelId="{0EBC65B5-F4BF-4DD4-8F5B-B475514F84C5}" type="presParOf" srcId="{F3F68AC9-0F9C-4FA6-A7B2-AF1E66043D18}" destId="{F088B1F5-2013-49F0-AC32-01CE1340DBAC}" srcOrd="4" destOrd="0" presId="urn:microsoft.com/office/officeart/2005/8/layout/hProcess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08CBE4-2ADB-4F7C-9557-AC3A47690629}">
      <dsp:nvSpPr>
        <dsp:cNvPr id="0" name=""/>
        <dsp:cNvSpPr/>
      </dsp:nvSpPr>
      <dsp:spPr>
        <a:xfrm>
          <a:off x="27983" y="907928"/>
          <a:ext cx="2309897" cy="190518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171450" lvl="1" indent="-171450" algn="l" defTabSz="7556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None/>
          </a:pPr>
          <a:endParaRPr lang="en-US" sz="17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114300" lvl="1" indent="-114300" algn="l" defTabSz="6667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US" sz="15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atient partners educational background did not include training about clinical trials. They are not experienced researchers</a:t>
          </a:r>
        </a:p>
        <a:p>
          <a:pPr marL="171450" lvl="1" indent="-171450" algn="l" defTabSz="7556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None/>
          </a:pPr>
          <a:endParaRPr lang="en-US" sz="17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1827" y="951772"/>
        <a:ext cx="2222209" cy="1409240"/>
      </dsp:txXfrm>
    </dsp:sp>
    <dsp:sp modelId="{4FF0DDFF-DF08-466A-99C3-B255489F7E98}">
      <dsp:nvSpPr>
        <dsp:cNvPr id="0" name=""/>
        <dsp:cNvSpPr/>
      </dsp:nvSpPr>
      <dsp:spPr>
        <a:xfrm>
          <a:off x="1292229" y="1477136"/>
          <a:ext cx="2595883" cy="2595883"/>
        </a:xfrm>
        <a:prstGeom prst="leftCircularArrow">
          <a:avLst>
            <a:gd name="adj1" fmla="val 3340"/>
            <a:gd name="adj2" fmla="val 412824"/>
            <a:gd name="adj3" fmla="val 2188334"/>
            <a:gd name="adj4" fmla="val 9024489"/>
            <a:gd name="adj5" fmla="val 3897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A3B0638-4798-4C67-99BB-21C7FC8B54AD}">
      <dsp:nvSpPr>
        <dsp:cNvPr id="0" name=""/>
        <dsp:cNvSpPr/>
      </dsp:nvSpPr>
      <dsp:spPr>
        <a:xfrm>
          <a:off x="516578" y="2553137"/>
          <a:ext cx="2053241" cy="816506"/>
        </a:xfrm>
        <a:prstGeom prst="roundRect">
          <a:avLst>
            <a:gd name="adj" fmla="val 10000"/>
          </a:avLst>
        </a:prstGeom>
        <a:gradFill rotWithShape="1">
          <a:gsLst>
            <a:gs pos="0">
              <a:schemeClr val="dk1">
                <a:lumMod val="110000"/>
                <a:satMod val="105000"/>
                <a:tint val="67000"/>
              </a:schemeClr>
            </a:gs>
            <a:gs pos="50000">
              <a:schemeClr val="dk1">
                <a:lumMod val="105000"/>
                <a:satMod val="103000"/>
                <a:tint val="73000"/>
              </a:schemeClr>
            </a:gs>
            <a:gs pos="100000">
              <a:schemeClr val="dk1">
                <a:lumMod val="105000"/>
                <a:satMod val="109000"/>
                <a:tint val="81000"/>
              </a:schemeClr>
            </a:gs>
          </a:gsLst>
          <a:lin ang="5400000" scaled="0"/>
        </a:gradFill>
        <a:ln w="635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1">
          <a:schemeClr val="dk1"/>
        </a:lnRef>
        <a:fillRef idx="2">
          <a:schemeClr val="dk1"/>
        </a:fillRef>
        <a:effectRef idx="1">
          <a:schemeClr val="dk1"/>
        </a:effectRef>
        <a:fontRef idx="minor">
          <a:schemeClr val="dk1"/>
        </a:fontRef>
      </dsp:style>
      <dsp:txBody>
        <a:bodyPr spcFirstLastPara="0" vert="horz" wrap="square" lIns="59055" tIns="39370" rIns="59055" bIns="39370" numCol="1" spcCol="1270" anchor="ctr" anchorCtr="0">
          <a:noAutofit/>
        </a:bodyPr>
        <a:lstStyle/>
        <a:p>
          <a:pPr marL="0" lvl="0" indent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/>
            <a:t>Context</a:t>
          </a:r>
        </a:p>
      </dsp:txBody>
      <dsp:txXfrm>
        <a:off x="540493" y="2577052"/>
        <a:ext cx="2005411" cy="768676"/>
      </dsp:txXfrm>
    </dsp:sp>
    <dsp:sp modelId="{5412F56F-93F3-4242-95C3-38727FCF1745}">
      <dsp:nvSpPr>
        <dsp:cNvPr id="0" name=""/>
        <dsp:cNvSpPr/>
      </dsp:nvSpPr>
      <dsp:spPr>
        <a:xfrm>
          <a:off x="2982672" y="1056208"/>
          <a:ext cx="2309897" cy="190518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1355300"/>
              <a:satOff val="50000"/>
              <a:lumOff val="-7353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114300" lvl="1" indent="-114300" algn="l" defTabSz="6667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5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cademic researcher perceives patient partners’ readiness to research (in this case, their lack of readiness)</a:t>
          </a:r>
        </a:p>
      </dsp:txBody>
      <dsp:txXfrm>
        <a:off x="3026516" y="1508306"/>
        <a:ext cx="2222209" cy="1409240"/>
      </dsp:txXfrm>
    </dsp:sp>
    <dsp:sp modelId="{6672AEE6-8509-4FED-9F07-0B28892F3E01}">
      <dsp:nvSpPr>
        <dsp:cNvPr id="0" name=""/>
        <dsp:cNvSpPr/>
      </dsp:nvSpPr>
      <dsp:spPr>
        <a:xfrm>
          <a:off x="4208648" y="-77680"/>
          <a:ext cx="2945839" cy="2945839"/>
        </a:xfrm>
        <a:prstGeom prst="circularArrow">
          <a:avLst>
            <a:gd name="adj1" fmla="val 2943"/>
            <a:gd name="adj2" fmla="val 360390"/>
            <a:gd name="adj3" fmla="val 19657389"/>
            <a:gd name="adj4" fmla="val 12768801"/>
            <a:gd name="adj5" fmla="val 3434"/>
          </a:avLst>
        </a:prstGeom>
        <a:solidFill>
          <a:schemeClr val="accent3">
            <a:hueOff val="2710599"/>
            <a:satOff val="100000"/>
            <a:lumOff val="-14706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2C7E8F2-C81A-4039-8494-624928C37673}">
      <dsp:nvSpPr>
        <dsp:cNvPr id="0" name=""/>
        <dsp:cNvSpPr/>
      </dsp:nvSpPr>
      <dsp:spPr>
        <a:xfrm>
          <a:off x="3495982" y="647955"/>
          <a:ext cx="2053241" cy="816506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tx1">
                <a:lumMod val="65000"/>
                <a:lumOff val="35000"/>
              </a:schemeClr>
            </a:gs>
            <a:gs pos="50000">
              <a:schemeClr val="dk1">
                <a:satMod val="110000"/>
                <a:lumMod val="100000"/>
                <a:shade val="100000"/>
              </a:schemeClr>
            </a:gs>
            <a:gs pos="100000">
              <a:schemeClr val="dk1">
                <a:lumMod val="99000"/>
                <a:satMod val="120000"/>
                <a:shade val="78000"/>
              </a:schemeClr>
            </a:gs>
          </a:gsLst>
          <a:lin ang="5400000" scaled="0"/>
        </a:gradFill>
        <a:ln w="635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1">
          <a:schemeClr val="dk1"/>
        </a:lnRef>
        <a:fillRef idx="3">
          <a:schemeClr val="dk1"/>
        </a:fillRef>
        <a:effectRef idx="2">
          <a:schemeClr val="dk1"/>
        </a:effectRef>
        <a:fontRef idx="minor">
          <a:schemeClr val="lt1"/>
        </a:fontRef>
      </dsp:style>
      <dsp:txBody>
        <a:bodyPr spcFirstLastPara="0" vert="horz" wrap="square" lIns="59055" tIns="39370" rIns="59055" bIns="39370" numCol="1" spcCol="1270" anchor="ctr" anchorCtr="0">
          <a:noAutofit/>
        </a:bodyPr>
        <a:lstStyle/>
        <a:p>
          <a:pPr marL="0" lvl="0" indent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/>
            <a:t>Mechanism</a:t>
          </a:r>
        </a:p>
      </dsp:txBody>
      <dsp:txXfrm>
        <a:off x="3519897" y="671870"/>
        <a:ext cx="2005411" cy="768676"/>
      </dsp:txXfrm>
    </dsp:sp>
    <dsp:sp modelId="{B118BAD4-2ED1-4EB5-AE0C-2C119827D1D4}">
      <dsp:nvSpPr>
        <dsp:cNvPr id="0" name=""/>
        <dsp:cNvSpPr/>
      </dsp:nvSpPr>
      <dsp:spPr>
        <a:xfrm>
          <a:off x="6005941" y="1190981"/>
          <a:ext cx="2309897" cy="1905182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2710599"/>
              <a:satOff val="100000"/>
              <a:lumOff val="-14706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3825" tIns="123825" rIns="123825" bIns="123825" numCol="1" spcCol="1270" anchor="t" anchorCtr="0">
          <a:noAutofit/>
        </a:bodyPr>
        <a:lstStyle/>
        <a:p>
          <a:pPr marL="114300" lvl="1" indent="-114300" algn="l" defTabSz="6667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5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cademic researcher perceives a sense of frustration over their need to educate patient partners</a:t>
          </a:r>
        </a:p>
      </dsp:txBody>
      <dsp:txXfrm>
        <a:off x="6049785" y="1234825"/>
        <a:ext cx="2222209" cy="1409240"/>
      </dsp:txXfrm>
    </dsp:sp>
    <dsp:sp modelId="{A543B595-5D4C-4FF3-AD91-0DC27AAAA981}">
      <dsp:nvSpPr>
        <dsp:cNvPr id="0" name=""/>
        <dsp:cNvSpPr/>
      </dsp:nvSpPr>
      <dsp:spPr>
        <a:xfrm>
          <a:off x="6475284" y="2587406"/>
          <a:ext cx="2053447" cy="747969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tx2"/>
            </a:gs>
            <a:gs pos="50000">
              <a:schemeClr val="dk1">
                <a:satMod val="110000"/>
                <a:lumMod val="100000"/>
                <a:shade val="100000"/>
              </a:schemeClr>
            </a:gs>
            <a:gs pos="100000">
              <a:schemeClr val="dk1"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hemeClr val="dk1"/>
        </a:lnRef>
        <a:fillRef idx="3">
          <a:schemeClr val="dk1"/>
        </a:fillRef>
        <a:effectRef idx="3">
          <a:schemeClr val="dk1"/>
        </a:effectRef>
        <a:fontRef idx="minor">
          <a:schemeClr val="lt1"/>
        </a:fontRef>
      </dsp:style>
      <dsp:txBody>
        <a:bodyPr spcFirstLastPara="0" vert="horz" wrap="square" lIns="59055" tIns="39370" rIns="59055" bIns="39370" numCol="1" spcCol="1270" anchor="ctr" anchorCtr="0">
          <a:noAutofit/>
        </a:bodyPr>
        <a:lstStyle/>
        <a:p>
          <a:pPr marL="0" lvl="0" indent="0" algn="ctr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/>
            <a:t>Outcome</a:t>
          </a:r>
        </a:p>
      </dsp:txBody>
      <dsp:txXfrm>
        <a:off x="6497191" y="2609313"/>
        <a:ext cx="2009633" cy="70415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4">
  <dgm:title val=""/>
  <dgm:desc val=""/>
  <dgm:catLst>
    <dgm:cat type="process" pri="4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w" for="ch" forName="tSp" refType="w"/>
      <dgm:constr type="h" for="ch" forName="tSp" refType="h" fact="0.15"/>
      <dgm:constr type="l" for="ch" forName="tSp"/>
      <dgm:constr type="t" for="ch" forName="tSp"/>
      <dgm:constr type="w" for="ch" forName="bSp" refType="w"/>
      <dgm:constr type="h" for="ch" forName="bSp" refType="h" fact="0.15"/>
      <dgm:constr type="l" for="ch" forName="bSp"/>
      <dgm:constr type="t" for="ch" forName="bSp" refType="h" fact="0.85"/>
      <dgm:constr type="w" for="ch" forName="process" refType="w"/>
      <dgm:constr type="h" for="ch" forName="process" refType="h" fact="0.7"/>
      <dgm:constr type="l" for="ch" forName="process"/>
      <dgm:constr type="t" for="ch" forName="process" refType="h" fact="0.15"/>
    </dgm:constrLst>
    <dgm:ruleLst/>
    <dgm:layoutNode name="tSp">
      <dgm:alg type="sp"/>
      <dgm:shape xmlns:r="http://schemas.openxmlformats.org/officeDocument/2006/relationships" r:blip="">
        <dgm:adjLst/>
      </dgm:shape>
      <dgm:presOf/>
      <dgm:constrLst/>
      <dgm:ruleLst/>
    </dgm:layoutNode>
    <dgm:layoutNode name="bSp">
      <dgm:alg type="sp"/>
      <dgm:shape xmlns:r="http://schemas.openxmlformats.org/officeDocument/2006/relationships" r:blip="">
        <dgm:adjLst/>
      </dgm:shape>
      <dgm:presOf/>
      <dgm:constrLst/>
      <dgm:ruleLst/>
    </dgm:layoutNode>
    <dgm:layoutNode name="process">
      <dgm:choose name="Name1">
        <dgm:if name="Name2" func="var" arg="dir" op="equ" val="norm">
          <dgm:alg type="lin">
            <dgm:param type="linDir" val="fromL"/>
          </dgm:alg>
        </dgm:if>
        <dgm:else name="Name3">
          <dgm:alg type="lin">
            <dgm:param type="linDir" val="fromR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omposite1" refType="w"/>
        <dgm:constr type="w" for="ch" forName="composite2" refType="w" refFor="ch" refForName="composite1" op="equ"/>
        <dgm:constr type="h" for="ch" forName="composite1" refType="h"/>
        <dgm:constr type="h" for="ch" forName="composite2" refType="h" refFor="ch" refForName="composite1" op="equ"/>
        <dgm:constr type="primFontSz" for="des" forName="parentNode1" val="65"/>
        <dgm:constr type="primFontSz" for="des" forName="parentNode2" refType="primFontSz" refFor="des" refForName="parentNode1" op="equ"/>
        <dgm:constr type="secFontSz" for="des" forName="childNode1tx" val="65"/>
        <dgm:constr type="secFontSz" for="des" forName="childNode2tx" refType="secFontSz" refFor="des" refForName="childNode1tx" op="equ"/>
        <dgm:constr type="w" for="des" ptType="sibTrans" refType="w" refFor="ch" refForName="composite1" op="equ" fact="0.05"/>
      </dgm:constrLst>
      <dgm:ruleLst/>
      <dgm:forEach name="Name4" axis="ch" ptType="node" step="2">
        <dgm:layoutNode name="composite1">
          <dgm:alg type="composite">
            <dgm:param type="ar" val="0.943"/>
          </dgm:alg>
          <dgm:shape xmlns:r="http://schemas.openxmlformats.org/officeDocument/2006/relationships" r:blip="">
            <dgm:adjLst/>
          </dgm:shape>
          <dgm:presOf/>
          <dgm:choose name="Name5">
            <dgm:if name="Name6" func="var" arg="dir" op="equ" val="norm">
              <dgm:constrLst>
                <dgm:constr type="h" refType="w" fact="1.06"/>
                <dgm:constr type="w" for="ch" forName="dummyNode1" refType="w"/>
                <dgm:constr type="h" for="ch" forName="dummyNode1" refType="h"/>
                <dgm:constr type="t" for="ch" forName="dummyNode1"/>
                <dgm:constr type="l" for="ch" forName="dummyNode1"/>
                <dgm:constr type="w" for="ch" forName="childNode1" refType="w" fact="0.9"/>
                <dgm:constr type="h" for="ch" forName="childNode1" refType="h" fact="0.7"/>
                <dgm:constr type="t" for="ch" forName="childNode1" refType="h" fact="0.15"/>
                <dgm:constr type="l" for="ch" forName="childNode1"/>
                <dgm:constr type="w" for="ch" forName="childNode1tx" refType="w" fact="0.9"/>
                <dgm:constr type="h" for="ch" forName="childNode1tx" refType="h" fact="0.55"/>
                <dgm:constr type="t" for="ch" forName="childNode1tx" refType="h" fact="0.15"/>
                <dgm:constr type="l" for="ch" forName="childNode1tx"/>
                <dgm:constr type="w" for="ch" forName="parentNode1" refType="w" fact="0.8"/>
                <dgm:constr type="h" for="ch" forName="parentNode1" refType="h" fact="0.3"/>
                <dgm:constr type="t" for="ch" forName="parentNode1" refType="h" fact="0.7"/>
                <dgm:constr type="l" for="ch" forName="parentNode1" refType="w" fact="0.2"/>
                <dgm:constr type="w" for="ch" forName="connSite1" refType="w" fact="0.01"/>
                <dgm:constr type="h" for="ch" forName="connSite1" refType="h" fact="0.01"/>
                <dgm:constr type="t" for="ch" forName="connSite1"/>
                <dgm:constr type="l" for="ch" forName="connSite1" refType="w" fact="0.35"/>
              </dgm:constrLst>
            </dgm:if>
            <dgm:else name="Name7">
              <dgm:constrLst>
                <dgm:constr type="h" refType="w" fact="1.06"/>
                <dgm:constr type="w" for="ch" forName="dummyNode1" refType="w"/>
                <dgm:constr type="h" for="ch" forName="dummyNode1" refType="h"/>
                <dgm:constr type="t" for="ch" forName="dummyNode1"/>
                <dgm:constr type="l" for="ch" forName="dummyNode1"/>
                <dgm:constr type="w" for="ch" forName="childNode1" refType="w" fact="0.9"/>
                <dgm:constr type="h" for="ch" forName="childNode1" refType="h" fact="0.7"/>
                <dgm:constr type="t" for="ch" forName="childNode1" refType="h" fact="0.15"/>
                <dgm:constr type="l" for="ch" forName="childNode1" refType="w" fact="0.1"/>
                <dgm:constr type="w" for="ch" forName="childNode1tx" refType="w" fact="0.9"/>
                <dgm:constr type="h" for="ch" forName="childNode1tx" refType="h" fact="0.55"/>
                <dgm:constr type="t" for="ch" forName="childNode1tx" refType="h" fact="0.15"/>
                <dgm:constr type="l" for="ch" forName="childNode1tx" refType="w" fact="0.1"/>
                <dgm:constr type="w" for="ch" forName="parentNode1" refType="w" fact="0.8"/>
                <dgm:constr type="h" for="ch" forName="parentNode1" refType="h" fact="0.3"/>
                <dgm:constr type="t" for="ch" forName="parentNode1" refType="h" fact="0.7"/>
                <dgm:constr type="l" for="ch" forName="parentNode1"/>
                <dgm:constr type="w" for="ch" forName="connSite1" refType="w" fact="0.01"/>
                <dgm:constr type="h" for="ch" forName="connSite1" refType="h" fact="0.01"/>
                <dgm:constr type="t" for="ch" forName="connSite1"/>
                <dgm:constr type="l" for="ch" forName="connSite1" refType="w" fact="0.65"/>
              </dgm:constrLst>
            </dgm:else>
          </dgm:choose>
          <dgm:ruleLst/>
          <dgm:layoutNode name="dummyNode1">
            <dgm:alg type="sp"/>
            <dgm:shape xmlns:r="http://schemas.openxmlformats.org/officeDocument/2006/relationships" type="rect" r:blip="" hideGeom="1">
              <dgm:adjLst/>
            </dgm:shape>
            <dgm:presOf/>
            <dgm:constrLst/>
            <dgm:ruleLst/>
          </dgm:layoutNode>
          <dgm:layoutNode name="childNode1" styleLbl="bgAcc1">
            <dgm:varLst>
              <dgm:bulletEnabled val="1"/>
            </dgm:varLst>
            <dgm:alg type="sp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" ptType="node"/>
            <dgm:constrLst/>
            <dgm:ruleLst/>
          </dgm:layoutNode>
          <dgm:layoutNode name="childNode1tx" styleLbl="bgAcc1">
            <dgm:varLst>
              <dgm:bulletEnabled val="1"/>
            </dgm:varLst>
            <dgm:alg type="tx">
              <dgm:param type="stBulletLvl" val="1"/>
            </dgm:alg>
            <dgm:shape xmlns:r="http://schemas.openxmlformats.org/officeDocument/2006/relationships" type="roundRect" r:blip="" hideGeom="1">
              <dgm:adjLst>
                <dgm:adj idx="1" val="0.1"/>
              </dgm:adjLst>
            </dgm:shape>
            <dgm:presOf axis="des" ptType="node"/>
            <dgm:constrLst>
              <dgm:constr type="secFontSz" val="65"/>
              <dgm:constr type="primFontSz" refType="secFontSz"/>
              <dgm:constr type="tMarg" refType="secFontSz" fact="0.15"/>
              <dgm:constr type="bMarg" refType="secFontSz" fact="0.15"/>
              <dgm:constr type="lMarg" refType="secFontSz" fact="0.15"/>
              <dgm:constr type="rMarg" refType="secFontSz" fact="0.15"/>
            </dgm:constrLst>
            <dgm:ruleLst>
              <dgm:rule type="secFontSz" val="5" fact="NaN" max="NaN"/>
            </dgm:ruleLst>
          </dgm:layoutNode>
          <dgm:layoutNode name="parentNode1" styleLbl="node1">
            <dgm:varLst>
              <dgm:chMax val="1"/>
              <dgm:bulletEnabled val="1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1"/>
              <dgm:constr type="bMarg" refType="primFontSz" fact="0.1"/>
              <dgm:constr type="lMarg" refType="primFontSz" fact="0.15"/>
              <dgm:constr type="rMarg" refType="primFontSz" fact="0.15"/>
            </dgm:constrLst>
            <dgm:ruleLst>
              <dgm:rule type="primFontSz" val="5" fact="NaN" max="NaN"/>
            </dgm:ruleLst>
          </dgm:layoutNode>
          <dgm:layoutNode name="connSite1" moveWith="childNode1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layoutNode>
        <dgm:forEach name="Name8" axis="followSib" ptType="sibTrans" cnt="1">
          <dgm:layoutNode name="Name9">
            <dgm:alg type="conn">
              <dgm:param type="connRout" val="curve"/>
              <dgm:param type="srcNode" val="parentNode1"/>
              <dgm:param type="dstNode" val="connSite2"/>
              <dgm:param type="begPts" val="bCtr"/>
              <dgm:param type="endPts" val="bCtr"/>
            </dgm:alg>
            <dgm:shape xmlns:r="http://schemas.openxmlformats.org/officeDocument/2006/relationships" type="conn" r:blip="" zOrderOff="-2">
              <dgm:adjLst/>
            </dgm:shape>
            <dgm:presOf axis="self"/>
            <dgm:choose name="Name10">
              <dgm:if name="Name11" func="var" arg="dir" op="equ" val="norm">
                <dgm:constrLst>
                  <dgm:constr type="h" refType="w" fact="0.35"/>
                  <dgm:constr type="wArH" refType="h"/>
                  <dgm:constr type="hArH" refType="h"/>
                  <dgm:constr type="connDist"/>
                  <dgm:constr type="diam" refType="connDist" fact="-1.15"/>
                  <dgm:constr type="begPad"/>
                  <dgm:constr type="endPad"/>
                </dgm:constrLst>
              </dgm:if>
              <dgm:else name="Name12">
                <dgm:constrLst>
                  <dgm:constr type="h" refType="w" fact="0.35"/>
                  <dgm:constr type="wArH" refType="h"/>
                  <dgm:constr type="hArH" refType="h"/>
                  <dgm:constr type="connDist"/>
                  <dgm:constr type="diam" refType="connDist" fact="1.15"/>
                  <dgm:constr type="begPad"/>
                  <dgm:constr type="endPad"/>
                </dgm:constrLst>
              </dgm:else>
            </dgm:choose>
            <dgm:ruleLst/>
          </dgm:layoutNode>
        </dgm:forEach>
        <dgm:forEach name="Name13" axis="followSib" ptType="node" cnt="1">
          <dgm:layoutNode name="composite2">
            <dgm:alg type="composite">
              <dgm:param type="ar" val="0.943"/>
            </dgm:alg>
            <dgm:shape xmlns:r="http://schemas.openxmlformats.org/officeDocument/2006/relationships" r:blip="">
              <dgm:adjLst/>
            </dgm:shape>
            <dgm:presOf/>
            <dgm:choose name="Name14">
              <dgm:if name="Name15" func="var" arg="dir" op="equ" val="norm">
                <dgm:constrLst>
                  <dgm:constr type="h" refType="w" fact="1.06"/>
                  <dgm:constr type="w" for="ch" forName="dummyNode2" refType="w"/>
                  <dgm:constr type="h" for="ch" forName="dummyNode2" refType="h"/>
                  <dgm:constr type="t" for="ch" forName="dummyNode2"/>
                  <dgm:constr type="l" for="ch" forName="dummyNode2"/>
                  <dgm:constr type="w" for="ch" forName="childNode2" refType="w" fact="0.9"/>
                  <dgm:constr type="h" for="ch" forName="childNode2" refType="h" fact="0.7"/>
                  <dgm:constr type="t" for="ch" forName="childNode2" refType="h" fact="0.15"/>
                  <dgm:constr type="l" for="ch" forName="childNode2"/>
                  <dgm:constr type="w" for="ch" forName="childNode2tx" refType="w" fact="0.9"/>
                  <dgm:constr type="h" for="ch" forName="childNode2tx" refType="h" fact="0.55"/>
                  <dgm:constr type="t" for="ch" forName="childNode2tx" refType="h" fact="0.3"/>
                  <dgm:constr type="l" for="ch" forName="childNode2tx"/>
                  <dgm:constr type="w" for="ch" forName="parentNode2" refType="w" fact="0.8"/>
                  <dgm:constr type="h" for="ch" forName="parentNode2" refType="h" fact="0.3"/>
                  <dgm:constr type="t" for="ch" forName="parentNode2"/>
                  <dgm:constr type="l" for="ch" forName="parentNode2" refType="w" fact="0.2"/>
                  <dgm:constr type="w" for="ch" forName="connSite2" refType="w" fact="0.01"/>
                  <dgm:constr type="h" for="ch" forName="connSite2" refType="h" fact="0.01"/>
                  <dgm:constr type="t" for="ch" forName="connSite2" refType="h" fact="0.99"/>
                  <dgm:constr type="l" for="ch" forName="connSite2" refType="w" fact="0.25"/>
                </dgm:constrLst>
              </dgm:if>
              <dgm:else name="Name16">
                <dgm:constrLst>
                  <dgm:constr type="h" refType="w" fact="1.06"/>
                  <dgm:constr type="w" for="ch" forName="dummyNode2" refType="w"/>
                  <dgm:constr type="h" for="ch" forName="dummyNode2" refType="h"/>
                  <dgm:constr type="t" for="ch" forName="dummyNode2"/>
                  <dgm:constr type="l" for="ch" forName="dummyNode2"/>
                  <dgm:constr type="w" for="ch" forName="childNode2" refType="w" fact="0.9"/>
                  <dgm:constr type="h" for="ch" forName="childNode2" refType="h" fact="0.7"/>
                  <dgm:constr type="t" for="ch" forName="childNode2" refType="h" fact="0.15"/>
                  <dgm:constr type="l" for="ch" forName="childNode2" refType="w" fact="0.1"/>
                  <dgm:constr type="w" for="ch" forName="childNode2tx" refType="w" fact="0.9"/>
                  <dgm:constr type="h" for="ch" forName="childNode2tx" refType="h" fact="0.55"/>
                  <dgm:constr type="t" for="ch" forName="childNode2tx" refType="h" fact="0.3"/>
                  <dgm:constr type="l" for="ch" forName="childNode2tx" refType="w" fact="0.1"/>
                  <dgm:constr type="w" for="ch" forName="parentNode2" refType="w" fact="0.8"/>
                  <dgm:constr type="h" for="ch" forName="parentNode2" refType="h" fact="0.3"/>
                  <dgm:constr type="t" for="ch" forName="parentNode2"/>
                  <dgm:constr type="l" for="ch" forName="parentNode2"/>
                  <dgm:constr type="w" for="ch" forName="connSite2" refType="w" fact="0.01"/>
                  <dgm:constr type="h" for="ch" forName="connSite2" refType="h" fact="0.01"/>
                  <dgm:constr type="t" for="ch" forName="connSite2" refType="h" fact="0.99"/>
                  <dgm:constr type="l" for="ch" forName="connSite2" refType="w" fact="0.85"/>
                </dgm:constrLst>
              </dgm:else>
            </dgm:choose>
            <dgm:ruleLst/>
            <dgm:layoutNode name="dummyNode2">
              <dgm:alg type="sp"/>
              <dgm:shape xmlns:r="http://schemas.openxmlformats.org/officeDocument/2006/relationships" type="rect" r:blip="" hideGeom="1">
                <dgm:adjLst/>
              </dgm:shape>
              <dgm:presOf/>
              <dgm:constrLst/>
              <dgm:ruleLst/>
            </dgm:layoutNode>
            <dgm:layoutNode name="childNode2" styleLbl="bgAcc1">
              <dgm:varLst>
                <dgm:bulletEnabled val="1"/>
              </dgm:varLst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des" ptType="node"/>
              <dgm:constrLst/>
              <dgm:ruleLst/>
            </dgm:layoutNode>
            <dgm:layoutNode name="childNode2tx" styleLbl="bgAcc1">
              <dgm:varLst>
                <dgm:bulletEnabled val="1"/>
              </dgm:varLst>
              <dgm:alg type="tx">
                <dgm:param type="stBulletLvl" val="1"/>
              </dgm:alg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15"/>
                <dgm:constr type="bMarg" refType="secFontSz" fact="0.15"/>
                <dgm:constr type="lMarg" refType="secFontSz" fact="0.15"/>
                <dgm:constr type="rMarg" refType="secFontSz" fact="0.15"/>
              </dgm:constrLst>
              <dgm:ruleLst>
                <dgm:rule type="secFontSz" val="5" fact="NaN" max="NaN"/>
              </dgm:ruleLst>
            </dgm:layoutNode>
            <dgm:layoutNode name="parentNode2" styleLbl="node1">
              <dgm:varLst>
                <dgm:chMax val="0"/>
                <dgm:bulletEnabled val="1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connSite2" moveWith="childNode2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layoutNode>
          <dgm:forEach name="Name17" axis="followSib" ptType="sibTrans" cnt="1">
            <dgm:layoutNode name="Name18">
              <dgm:alg type="conn">
                <dgm:param type="connRout" val="curve"/>
                <dgm:param type="srcNode" val="parentNode2"/>
                <dgm:param type="dstNode" val="connSite1"/>
                <dgm:param type="begPts" val="tCtr"/>
                <dgm:param type="endPts" val="tCtr"/>
              </dgm:alg>
              <dgm:shape xmlns:r="http://schemas.openxmlformats.org/officeDocument/2006/relationships" type="conn" r:blip="" zOrderOff="-2">
                <dgm:adjLst/>
              </dgm:shape>
              <dgm:presOf axis="self"/>
              <dgm:choose name="Name19">
                <dgm:if name="Name20" func="var" arg="dir" op="equ" val="norm">
                  <dgm:constrLst>
                    <dgm:constr type="h" refType="w" fact="0.35"/>
                    <dgm:constr type="wArH" refType="h"/>
                    <dgm:constr type="hArH" refType="h"/>
                    <dgm:constr type="connDist"/>
                    <dgm:constr type="diam" refType="connDist" fact="1.15"/>
                    <dgm:constr type="begPad"/>
                    <dgm:constr type="endPad"/>
                  </dgm:constrLst>
                </dgm:if>
                <dgm:else name="Name21">
                  <dgm:constrLst>
                    <dgm:constr type="h" refType="w" fact="0.35"/>
                    <dgm:constr type="wArH" refType="h"/>
                    <dgm:constr type="hArH" refType="h"/>
                    <dgm:constr type="connDist"/>
                    <dgm:constr type="diam" refType="connDist" fact="-1.15"/>
                    <dgm:constr type="begPad"/>
                    <dgm:constr type="endPad"/>
                  </dgm:constrLst>
                </dgm:else>
              </dgm:choose>
              <dgm:ruleLst/>
            </dgm:layoutNode>
          </dgm:forEach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DA32F-7AD1-41DB-9491-41C80CDC7C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FA7302-A144-4963-81F0-9DFFDB0F0A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0124C-2A90-4C65-99CC-DB0DE0FE8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A345D8-22A5-44C4-867C-8D3542B66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EA9DF-4076-491C-939D-49C3205E3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422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6AEFD-C254-4CBE-AC1A-3D6E5B8F0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8401AD-524C-4C38-BDB0-2AB5175E90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D4DAA4-0502-4D98-84FD-EE1850AE7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198C88-3286-4C77-B84B-482F88866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071DE-FED0-4492-9866-5C38E8B7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852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652149-D6C3-448B-9945-B04A42768B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361153-2EAA-48DA-9875-CA59343D6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046F1-72B8-4E7E-9D81-3817B753D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6E9C4-2BB9-418D-B960-8CC07E9DD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660AE6-D7C5-4F6C-91E8-6FAA31C95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030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3A245-C42A-4C5D-A3CD-295E678738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550E37-3DFB-4354-B911-26E5D6A882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27F03-FEAF-4BA1-800C-C313A62CF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C523F-7534-47AF-8114-AC132A288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D8732F-A347-4134-A172-761BB3B64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49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30AF08-2189-4482-8396-6989B5ACE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83222E-96A9-4315-9E2C-109C4FBC04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17458E-1840-46E0-9755-979E9C26B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28980-7E75-4EDE-A8F0-760D10A12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1B485-4A4D-49C0-B305-0BB0C2991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879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8D1CA-EA26-4C8B-8F85-5CF949C35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9B78B0-46EC-4F9C-A488-A74164DF86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39D2F9-0D7C-46A3-8479-8E4BE50857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17ABD5-B7B4-4748-8B40-2A9AF62FB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5E9E3C-78D7-4668-8847-BC6E2637E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E245E1-905C-45CE-987F-BAFF462E3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716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4158A-64F9-4491-AFE6-52ECCC3AB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7755FE-8A8C-46F7-A297-423922B87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A32C0F-D58F-410C-BB71-E240EBD878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C699E1-B34E-4C98-AE46-5F58DE861F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EA7F25-AAB9-4C87-A48D-266283E2F1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592B27-6E82-4FFF-AC7B-D5728CACD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2D02CD1-BD85-4623-9FAB-06A8E24B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4B5CFE-BF49-454D-A79F-E7D71D243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887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7DB14-8B48-46A0-AE00-1703303FFC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4C68EA-B372-4368-B600-2A3DFF744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F200C2-A3BC-430F-9708-76924ACD2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DE675D-170C-40ED-BC27-D43E43D0A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559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687069-476B-49B7-BFC3-59702A71F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D9133E-C714-43B4-8EDC-71F4B5317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D34F44-2D81-43D5-91DE-D95D62723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519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8FB73-1970-4E3E-BE1B-FE33F10973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7E26F6-706B-4469-856C-ED616042DC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979E96-2721-4F85-B093-96A3B03EDA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88AEB0-608B-4608-918D-64B919653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6C1441-0919-486D-A108-72914B1A9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6F4D66-A305-4B50-88A8-152E2E057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10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3E008-437F-4A4B-BA27-F647C6412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CB1258-34BA-4F10-87B4-6DD0AEF732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E2C3BD-0385-4E16-8DEB-9488DCDCC0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2C5ACF-322E-4503-9109-AF7C68BB6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C3929A-4F76-42FC-95BB-550B5D370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33E952-23B1-423D-8C11-17767C007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479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15B97B-0C22-4BBB-A65C-EF52CE5495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EB43A-C4B2-4A94-9DAE-E00AF678C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817CE8-AC4E-4CC0-B946-B3029E3B16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681DD-03DD-47CA-A011-B5B1226B9727}" type="datetimeFigureOut">
              <a:rPr lang="en-US" smtClean="0"/>
              <a:t>8/1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B6A7B9-F413-4FA5-A766-4EB5E3A2F3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BBD76-62E7-4A0E-A55D-2CFF22C319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B20CD-B2AE-482C-9A41-4D320558B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30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5D6123D3-7800-4908-9131-093E3CC9B1F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78950496"/>
              </p:ext>
            </p:extLst>
          </p:nvPr>
        </p:nvGraphicFramePr>
        <p:xfrm>
          <a:off x="1830000" y="2791246"/>
          <a:ext cx="8532000" cy="40176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37786E88-6AF2-4929-B7D6-5EEEB3902015}"/>
              </a:ext>
            </a:extLst>
          </p:cNvPr>
          <p:cNvSpPr/>
          <p:nvPr/>
        </p:nvSpPr>
        <p:spPr>
          <a:xfrm>
            <a:off x="2310714" y="349895"/>
            <a:ext cx="721634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i="1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“Time consuming. Although wanting to be involved, they were extremely naive about the research process and funding problems. </a:t>
            </a:r>
            <a:r>
              <a:rPr lang="en-US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” </a:t>
            </a:r>
          </a:p>
          <a:p>
            <a:pPr algn="ctr"/>
            <a:r>
              <a:rPr lang="en-US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Extracted Text </a:t>
            </a:r>
            <a:r>
              <a:rPr lang="en-US" sz="15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[121]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702DC37-A8A8-46B9-8CA8-E80C39185E09}"/>
              </a:ext>
            </a:extLst>
          </p:cNvPr>
          <p:cNvSpPr/>
          <p:nvPr/>
        </p:nvSpPr>
        <p:spPr>
          <a:xfrm>
            <a:off x="2348845" y="1384915"/>
            <a:ext cx="7494310" cy="26468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lanatory Account: “If patient partners do not have experience with randomized clinical trials, then academic researchers can experience frustration because they perceive they need to educate patient partners regarding funding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ow clinical trials research unfolds.” </a:t>
            </a:r>
          </a:p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br>
              <a:rPr lang="en-US" b="0" i="0" dirty="0">
                <a:solidFill>
                  <a:srgbClr val="000000"/>
                </a:solidFill>
                <a:effectLst/>
                <a:latin typeface="Segoe UI" panose="020B0502040204020203" pitchFamily="34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0269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9</TotalTime>
  <Words>123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um, Ali</dc:creator>
  <cp:lastModifiedBy>Elaine</cp:lastModifiedBy>
  <cp:revision>26</cp:revision>
  <cp:lastPrinted>2021-03-18T15:18:40Z</cp:lastPrinted>
  <dcterms:created xsi:type="dcterms:W3CDTF">2020-06-08T16:16:53Z</dcterms:created>
  <dcterms:modified xsi:type="dcterms:W3CDTF">2021-08-10T14:03:08Z</dcterms:modified>
</cp:coreProperties>
</file>